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6858000" cy="994568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40" autoAdjust="0"/>
    <p:restoredTop sz="94660"/>
  </p:normalViewPr>
  <p:slideViewPr>
    <p:cSldViewPr snapToGrid="0" snapToObjects="1">
      <p:cViewPr varScale="1">
        <p:scale>
          <a:sx n="69" d="100"/>
          <a:sy n="69" d="100"/>
        </p:scale>
        <p:origin x="-132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E89D7E-8A48-0E46-9167-8DFA57CD5B16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42975" y="746125"/>
            <a:ext cx="4972050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724202"/>
            <a:ext cx="5486400" cy="447556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9446678"/>
            <a:ext cx="2971800" cy="49728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5A11F-1826-3642-BBF7-EA236A47CF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392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084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028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8524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3845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6086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962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99708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9016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072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748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0730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02CA3-5EC9-8141-A8AB-F3A67208CBD2}" type="datetimeFigureOut">
              <a:rPr kumimoji="1" lang="ja-JP" altLang="en-US" smtClean="0"/>
              <a:t>2020/1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80B7E0-CA80-EF40-A299-992A0A495F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382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4839634E-EA02-4CAC-BE61-DEB066BB65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2576" y="1758320"/>
            <a:ext cx="5378847" cy="2900765"/>
          </a:xfrm>
          <a:prstGeom prst="rect">
            <a:avLst/>
          </a:prstGeom>
        </p:spPr>
      </p:pic>
      <p:sp>
        <p:nvSpPr>
          <p:cNvPr id="2" name="正方形/長方形 1"/>
          <p:cNvSpPr/>
          <p:nvPr/>
        </p:nvSpPr>
        <p:spPr>
          <a:xfrm>
            <a:off x="800100" y="6338352"/>
            <a:ext cx="850392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 Changes in diameter of classical bases as determined by using a spread meter.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FB8F5AAA-2FA0-439F-9809-FB6148CB325F}"/>
              </a:ext>
            </a:extLst>
          </p:cNvPr>
          <p:cNvSpPr txBox="1"/>
          <p:nvPr/>
        </p:nvSpPr>
        <p:spPr>
          <a:xfrm>
            <a:off x="3327020" y="15746"/>
            <a:ext cx="27642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 </a:t>
            </a:r>
            <a:r>
              <a:rPr kumimoji="1" lang="en-US" altLang="ja-JP"/>
              <a:t>S1  </a:t>
            </a:r>
            <a:r>
              <a:rPr kumimoji="1" lang="en-US" altLang="ja-JP" dirty="0"/>
              <a:t>Yamamoto et al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8616979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8</TotalTime>
  <Words>24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ホワイト</vt:lpstr>
      <vt:lpstr>PowerPoint Presentation</vt:lpstr>
    </vt:vector>
  </TitlesOfParts>
  <Company>帝京平成大学薬学部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 佳久</dc:creator>
  <cp:lastModifiedBy>Manicani, Lyndie</cp:lastModifiedBy>
  <cp:revision>61</cp:revision>
  <cp:lastPrinted>2019-08-08T09:08:55Z</cp:lastPrinted>
  <dcterms:created xsi:type="dcterms:W3CDTF">2017-02-17T08:52:02Z</dcterms:created>
  <dcterms:modified xsi:type="dcterms:W3CDTF">2020-01-21T01:38:07Z</dcterms:modified>
</cp:coreProperties>
</file>